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418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13A89-1EA1-92F2-8AA2-78408AFC86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41EA5A-EB4F-1797-A73B-87258FB610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51ACA-AD1A-3E6F-FFA9-3170AA9BB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216908-7217-DCD8-2A78-CB58A490C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061263-A388-E0DF-EB3C-EFD3BC9AF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48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03768-8808-8E12-F9B8-AE194AB52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2DAC13-1DD7-3330-CF76-19A247ADE2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479D2-A2E7-F582-E60B-30E82239A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852A71-0B73-3991-AB66-047173A40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9CF39C-7F78-002E-DF0E-BA6662E1B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63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0151C3-82CD-EAD0-9956-24A7CC366F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58BF45-AAB3-B1B8-028B-6CB9E68EA6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818C1F-0155-94C0-67C6-E2A6E2033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8F44A-F4C0-57D6-0939-C6F31BCF9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283EB-DB7A-EFD8-3276-801C7B69F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80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2D243-B571-7AAC-1FDE-C41B01CB8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72628F-80E9-C7A5-6384-467D34CF62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94C221-199F-FE56-91F6-429FF12AE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A4B855-71A0-C3F3-FDF2-9A8D94D4E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2A6982-E599-9278-6D31-06E29CC57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347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F25FF-A719-383C-3DDF-7FAB4DE127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8C19C9-761E-7828-FE21-5CC7855247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E2B0F-0886-6525-E730-CDC2E9FAB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378C3F-CC58-09F9-B929-C87ACE0DD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F80EAB-A905-4E39-7CDC-0957BAE19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6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6A1037-17F0-29E9-A356-A3D18922C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15F4EF-180B-497E-AA49-22E9FCDACE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ED0F26-C6F4-E1C1-BC20-E17DF87885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17C6DA-1A6D-C592-67BE-4316773C0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680587-E822-58C2-CF42-828C8F0F5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2E8950-864F-B9E9-D955-1927A08B3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606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310BB-FC59-2ECC-D16C-CA9C8B32B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B5CDF1-28E2-324A-8D5A-66B1F55E81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F5FBBB-FDFD-87D4-6069-0087CBEBD8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F8DCF0-DCD7-0861-FB55-AEA976A1EE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D37029-C5F6-9265-7576-3A6059909D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AC9AAA-5CAB-62D1-861A-EC5C37F13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3DDB17-C76B-9CB8-F08A-C5F9A627A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928B5D-1A46-69AD-8FE6-C5E1436CB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742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5E5C8-7BCC-2F43-877E-E7D65B201E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6C962D-0537-40B9-971F-3900AF5DF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4B7FFA-AAC6-F8CA-6742-F0B36FEC6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35555A-F0BB-BA71-2685-05A129BCB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957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C279D5-DEE3-28F4-CB23-431F5C4BD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ED0875-4997-AB5E-7559-E8F90018A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BCB04F-CBA2-1E51-EE9D-A9D0924E2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805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DD609-4F73-801A-613F-7BB0157F1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966015-B272-66BC-A8D8-8B4ADE8685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A891CE-AF73-2A44-A44E-7B2A600D99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BD3D20-BB90-7774-DD93-A3026198D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6D9157-0861-F143-F3B9-6FB344D6A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5B78E8-E8CD-E647-BB6F-2041DE9C3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059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B2DFA-4B99-B2D0-CC52-8EB5EA6BC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6DC337-289D-9EAA-427E-09AF1CF745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4B8F27-F7FB-5C18-875F-9C6A65EFF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CC1027-AABC-9EE7-71CD-6B2540A36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B01694-4305-B654-D76B-A323EEFD6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74410B-3152-B891-0E65-64524021F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2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964E5E-1B8B-ADD9-825F-BF7DC4821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36D9F2-7D66-F471-4ACB-6D3B47F5F6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266093-8E15-8A53-2E23-85AB5D37F8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26868D-4ACC-4213-BCEB-522AE2381BE3}" type="datetimeFigureOut">
              <a:rPr lang="en-US" smtClean="0"/>
              <a:t>9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F236F-7108-EE34-16AA-3C23D69032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5FC914-40A0-C066-82FB-FB08036C84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6F474F-48FD-4639-B754-72CCBB8DE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259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C682C0B-B287-BD90-6E41-ED033CE584A0}"/>
              </a:ext>
            </a:extLst>
          </p:cNvPr>
          <p:cNvSpPr txBox="1"/>
          <p:nvPr/>
        </p:nvSpPr>
        <p:spPr>
          <a:xfrm>
            <a:off x="216898" y="5372091"/>
            <a:ext cx="115541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</a:t>
            </a:r>
            <a:r>
              <a:rPr lang="en-US" dirty="0"/>
              <a:t>. </a:t>
            </a:r>
            <a:r>
              <a:rPr lang="en-US" i="1" dirty="0"/>
              <a:t>Mouse body weights</a:t>
            </a:r>
            <a:r>
              <a:rPr lang="en-US" dirty="0"/>
              <a:t>. Weights of mice over the duration of study.  Graphed as mean +/- SD. n = 10 per group. </a:t>
            </a:r>
            <a:r>
              <a:rPr lang="en-US" dirty="0" err="1"/>
              <a:t>Omaveloxolone</a:t>
            </a:r>
            <a:r>
              <a:rPr lang="en-US" dirty="0"/>
              <a:t> treatment group n = 5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D8B691E4-19AB-439D-088D-A65B732F89D3}"/>
              </a:ext>
            </a:extLst>
          </p:cNvPr>
          <p:cNvGrpSpPr/>
          <p:nvPr/>
        </p:nvGrpSpPr>
        <p:grpSpPr>
          <a:xfrm>
            <a:off x="353744" y="57365"/>
            <a:ext cx="11233027" cy="4406900"/>
            <a:chOff x="500063" y="175282"/>
            <a:chExt cx="16693903" cy="6060418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85C8204F-BE92-2FF3-6B35-5CA1E22820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70183290"/>
                </p:ext>
              </p:extLst>
            </p:nvPr>
          </p:nvGraphicFramePr>
          <p:xfrm>
            <a:off x="500063" y="244475"/>
            <a:ext cx="5508625" cy="5991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872435" imgH="2974363" progId="Prism10.Document">
                    <p:embed/>
                  </p:oleObj>
                </mc:Choice>
                <mc:Fallback>
                  <p:oleObj name="Prism 10" r:id="rId2" imgW="2872435" imgH="2974363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85C8204F-BE92-2FF3-6B35-5CA1E22820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00063" y="244475"/>
                          <a:ext cx="5508625" cy="5991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06731254-D4AE-83B8-3BD2-3DC93B15B3E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5773760"/>
                </p:ext>
              </p:extLst>
            </p:nvPr>
          </p:nvGraphicFramePr>
          <p:xfrm>
            <a:off x="5690394" y="175282"/>
            <a:ext cx="6546604" cy="59846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416326" imgH="2974363" progId="Prism10.Document">
                    <p:embed/>
                  </p:oleObj>
                </mc:Choice>
                <mc:Fallback>
                  <p:oleObj name="Prism 10" r:id="rId4" imgW="3416326" imgH="2974363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06731254-D4AE-83B8-3BD2-3DC93B15B3E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690394" y="175282"/>
                          <a:ext cx="6546604" cy="59846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B6302CBE-F03D-FBE9-A497-3303D78AFBA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5835034"/>
                </p:ext>
              </p:extLst>
            </p:nvPr>
          </p:nvGraphicFramePr>
          <p:xfrm>
            <a:off x="11918704" y="371035"/>
            <a:ext cx="5275262" cy="57381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872435" imgH="2974363" progId="Prism10.Document">
                    <p:embed/>
                  </p:oleObj>
                </mc:Choice>
                <mc:Fallback>
                  <p:oleObj name="Prism 10" r:id="rId6" imgW="2872435" imgH="2974363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B6302CBE-F03D-FBE9-A497-3303D78AFBA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1918704" y="371035"/>
                          <a:ext cx="5275262" cy="57381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872684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cchiuto, Christopher</dc:creator>
  <cp:lastModifiedBy>Occhiuto, Christopher</cp:lastModifiedBy>
  <cp:revision>9</cp:revision>
  <dcterms:created xsi:type="dcterms:W3CDTF">2025-09-22T19:27:39Z</dcterms:created>
  <dcterms:modified xsi:type="dcterms:W3CDTF">2025-09-22T19:38:12Z</dcterms:modified>
</cp:coreProperties>
</file>